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E5C3AD2-4F83-435D-8419-49EC65B69F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87174" y="944499"/>
            <a:ext cx="6395999" cy="496900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5A0CE0C-B9DF-4345-88E0-DD5437F18408}"/>
              </a:ext>
            </a:extLst>
          </p:cNvPr>
          <p:cNvSpPr txBox="1"/>
          <p:nvPr/>
        </p:nvSpPr>
        <p:spPr>
          <a:xfrm>
            <a:off x="762098" y="6122381"/>
            <a:ext cx="11049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/>
              <a:t>Supplementary figure 4. A) MTT growth assay of C33A and HT3 cell lines. B) Soft agar colonies and, C) Representative pictures of soft agar colonies, and D) </a:t>
            </a:r>
            <a:r>
              <a:rPr lang="en-US" sz="1600" dirty="0">
                <a:solidFill>
                  <a:srgbClr val="000000"/>
                </a:solidFill>
                <a:effectLst/>
                <a:ea typeface="Malgun Gothic" panose="020B0503020000020004" pitchFamily="34" charset="-127"/>
              </a:rPr>
              <a:t>Snapshot view (IGV: interactive genome browser) of exon 8 SNP area of the RNA-seq of the two cell lines.</a:t>
            </a:r>
            <a:endParaRPr lang="en-US" sz="16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1E880C-19F6-4267-8486-CCF78F661626}"/>
              </a:ext>
            </a:extLst>
          </p:cNvPr>
          <p:cNvSpPr txBox="1"/>
          <p:nvPr/>
        </p:nvSpPr>
        <p:spPr>
          <a:xfrm>
            <a:off x="6568357" y="3943350"/>
            <a:ext cx="146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2 transcript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4B8A3CA-879E-4376-8A2C-4150653007FD}"/>
              </a:ext>
            </a:extLst>
          </p:cNvPr>
          <p:cNvSpPr txBox="1"/>
          <p:nvPr/>
        </p:nvSpPr>
        <p:spPr>
          <a:xfrm>
            <a:off x="6626865" y="5162550"/>
            <a:ext cx="1347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 transcrip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225DE7B-7DBC-44C6-845F-4CD1CC629E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827" y="989766"/>
            <a:ext cx="5444248" cy="492373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0AF2ADD-8D5C-4E87-A783-5C7BBC130A14}"/>
              </a:ext>
            </a:extLst>
          </p:cNvPr>
          <p:cNvSpPr txBox="1"/>
          <p:nvPr/>
        </p:nvSpPr>
        <p:spPr>
          <a:xfrm>
            <a:off x="181941" y="984177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C826D3A-EF43-4352-8726-614AEB26064B}"/>
              </a:ext>
            </a:extLst>
          </p:cNvPr>
          <p:cNvSpPr txBox="1"/>
          <p:nvPr/>
        </p:nvSpPr>
        <p:spPr>
          <a:xfrm>
            <a:off x="2851121" y="944496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BDD4C67-FDD2-4C60-88B5-A9BF99ED746A}"/>
              </a:ext>
            </a:extLst>
          </p:cNvPr>
          <p:cNvSpPr txBox="1"/>
          <p:nvPr/>
        </p:nvSpPr>
        <p:spPr>
          <a:xfrm>
            <a:off x="385165" y="3543240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F4F13C1-FDFB-4773-8016-92712E919A9F}"/>
              </a:ext>
            </a:extLst>
          </p:cNvPr>
          <p:cNvSpPr txBox="1"/>
          <p:nvPr/>
        </p:nvSpPr>
        <p:spPr>
          <a:xfrm>
            <a:off x="5286379" y="786917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66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3</cp:revision>
  <dcterms:created xsi:type="dcterms:W3CDTF">2024-02-09T21:19:49Z</dcterms:created>
  <dcterms:modified xsi:type="dcterms:W3CDTF">2024-02-09T21:36:52Z</dcterms:modified>
</cp:coreProperties>
</file>